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B5E1F-755F-48C9-BFFA-250F8EA9DE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D2FB0-62EF-498F-AFF9-14567B0E8E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F4067-654E-4AA5-AAB2-EACC372427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833782-BA80-4B3F-A32A-D91EBEFEE0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3983A-66D7-4BAB-99AE-83257126A1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5A428-0281-4945-80E1-7AC5F62385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D5207C-A92F-4847-B3ED-6EA54090AD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C1A296-0205-4B49-9645-C8760B294B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AA44F-F040-4D42-9854-451C83DAB6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5524D5-10C8-4283-99CA-3150B1BAB4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CB605-558A-49AF-AA5F-4D1ADB8E21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20523-6E82-405E-918C-F1D6CFC1D5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6EDA41-A6E9-4FCC-9F23-5F4C98B5C09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228600" y="304560"/>
            <a:ext cx="8686800" cy="99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: ANGPT2 AA population haplotype blocks. Block 2, highlighted in yellow, was associated with ALI by all 3 kernel function regressions (linear, IBS, and quadratic). In addition, this block contains the 2 SNPs previously reported to associate with trauma – associated ALI by Meyer et al 2011 [13]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228600" y="1414440"/>
            <a:ext cx="8915400" cy="50259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2838600" y="1523880"/>
            <a:ext cx="152280" cy="457200"/>
          </a:xfrm>
          <a:prstGeom prst="ellipse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090880" y="1981080"/>
            <a:ext cx="914400" cy="914400"/>
          </a:xfrm>
          <a:prstGeom prst="line">
            <a:avLst/>
          </a:prstGeom>
          <a:ln w="381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H="1">
            <a:off x="3014280" y="1933560"/>
            <a:ext cx="957240" cy="990720"/>
          </a:xfrm>
          <a:prstGeom prst="line">
            <a:avLst/>
          </a:prstGeom>
          <a:ln w="381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767040" y="1523880"/>
            <a:ext cx="152640" cy="457200"/>
          </a:xfrm>
          <a:prstGeom prst="ellipse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31T20:00:10Z</dcterms:created>
  <dc:creator>meyernua</dc:creator>
  <dc:description/>
  <dc:language>en-US</dc:language>
  <cp:lastModifiedBy>meyernua</cp:lastModifiedBy>
  <dcterms:modified xsi:type="dcterms:W3CDTF">2012-06-20T16:27:01Z</dcterms:modified>
  <cp:revision>4</cp:revision>
  <dc:subject/>
  <dc:title>Figure S1: ANGPT2 AA population haplotype blocks. Block 2, highlighted in yellow, was associated with ALI by all 3 kernel function regressions (linear, IBS, and quadratic). In addition, this block contains the 2 SNPs previously reported to associate with trauma – associated ALI by Meyer et al 2011 (13). </dc:title>
</cp:coreProperties>
</file>